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84" r:id="rId2"/>
    <p:sldId id="277" r:id="rId3"/>
    <p:sldId id="279" r:id="rId4"/>
    <p:sldId id="281" r:id="rId5"/>
    <p:sldId id="283" r:id="rId6"/>
    <p:sldId id="282" r:id="rId7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Estilo medio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 autoAdjust="0"/>
    <p:restoredTop sz="95646"/>
  </p:normalViewPr>
  <p:slideViewPr>
    <p:cSldViewPr snapToGrid="0">
      <p:cViewPr>
        <p:scale>
          <a:sx n="140" d="100"/>
          <a:sy n="140" d="100"/>
        </p:scale>
        <p:origin x="304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C42FAFD2-FADE-1B4C-9681-08A002DB6FE1}" type="datetimeFigureOut">
              <a:rPr lang="es-ES_tradnl" smtClean="0"/>
              <a:t>4/5/23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3488"/>
            <a:ext cx="2305050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378825"/>
            <a:ext cx="2945659" cy="49542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378825"/>
            <a:ext cx="2945659" cy="495426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BBD33155-2AF0-5B41-83A1-9B51FDD78E4A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0164144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75490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82678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25784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8757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75995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58892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37910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16153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08561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2117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77925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C4BC0-3AFE-4366-9EE2-AD7CC1D24388}" type="datetimeFigureOut">
              <a:rPr lang="es-MX" smtClean="0"/>
              <a:t>04/05/23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CE4A72-B903-486B-801E-040D058190B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93072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martin.heil@cinvestav.mx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95487AF-83E2-18E9-6679-7A132473F70A}"/>
              </a:ext>
            </a:extLst>
          </p:cNvPr>
          <p:cNvSpPr txBox="1"/>
          <p:nvPr/>
        </p:nvSpPr>
        <p:spPr>
          <a:xfrm>
            <a:off x="0" y="677333"/>
            <a:ext cx="6739467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Bef>
                <a:spcPts val="1200"/>
              </a:spcBef>
              <a:spcAft>
                <a:spcPts val="600"/>
              </a:spcAft>
            </a:pP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Material</a:t>
            </a:r>
            <a:endParaRPr lang="es-MX" sz="1600" b="1" i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Bef>
                <a:spcPts val="600"/>
              </a:spcBef>
              <a:spcAft>
                <a:spcPts val="1200"/>
              </a:spcAft>
            </a:pPr>
            <a:r>
              <a:rPr lang="en-GB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M and ATR, two central players of the DNA damage response, </a:t>
            </a:r>
            <a:br>
              <a:rPr lang="en-GB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 </a:t>
            </a:r>
            <a:r>
              <a:rPr lang="en-GB" sz="16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volved in the </a:t>
            </a:r>
            <a:r>
              <a:rPr lang="en-GB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uction of systemic acquired resistance by extracellular DNA, but not the plant wound response</a:t>
            </a:r>
            <a:endParaRPr lang="es-MX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Bef>
                <a:spcPts val="600"/>
              </a:spcBef>
              <a:spcAft>
                <a:spcPts val="1200"/>
              </a:spcAft>
            </a:pPr>
            <a:r>
              <a:rPr lang="en-GB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s-MX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aac Vega-Muñoz, Octavio Martínez-de la Vega, Alfredo Herrera-Estrella, Martin Heil</a:t>
            </a:r>
            <a:endParaRPr lang="es-MX" sz="16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Correspondence: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rtin Heil: </a:t>
            </a:r>
            <a:r>
              <a:rPr lang="en-US" sz="16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martin.heil@cinvestav.mx</a:t>
            </a:r>
            <a:endParaRPr lang="es-MX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s-MX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MX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 S1-S5</a:t>
            </a:r>
          </a:p>
        </p:txBody>
      </p:sp>
    </p:spTree>
    <p:extLst>
      <p:ext uri="{BB962C8B-B14F-4D97-AF65-F5344CB8AC3E}">
        <p14:creationId xmlns:p14="http://schemas.microsoft.com/office/powerpoint/2010/main" val="2955807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o 22">
            <a:extLst>
              <a:ext uri="{FF2B5EF4-FFF2-40B4-BE49-F238E27FC236}">
                <a16:creationId xmlns:a16="http://schemas.microsoft.com/office/drawing/2014/main" id="{F6517972-CC26-6879-11C1-4A4C0EBE86E2}"/>
              </a:ext>
            </a:extLst>
          </p:cNvPr>
          <p:cNvGrpSpPr/>
          <p:nvPr/>
        </p:nvGrpSpPr>
        <p:grpSpPr>
          <a:xfrm>
            <a:off x="1318566" y="1641128"/>
            <a:ext cx="4220868" cy="4613285"/>
            <a:chOff x="1233020" y="1038045"/>
            <a:chExt cx="4220868" cy="4613285"/>
          </a:xfrm>
        </p:grpSpPr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9024EB44-8DE1-38EF-3C93-1F2B5EA468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70888" y="1538491"/>
              <a:ext cx="3683000" cy="4112839"/>
            </a:xfrm>
            <a:prstGeom prst="rect">
              <a:avLst/>
            </a:prstGeom>
          </p:spPr>
        </p:pic>
        <p:grpSp>
          <p:nvGrpSpPr>
            <p:cNvPr id="11" name="Grupo 10">
              <a:extLst>
                <a:ext uri="{FF2B5EF4-FFF2-40B4-BE49-F238E27FC236}">
                  <a16:creationId xmlns:a16="http://schemas.microsoft.com/office/drawing/2014/main" id="{BC327A76-0EFC-5FE9-7CDC-6965344E4C61}"/>
                </a:ext>
              </a:extLst>
            </p:cNvPr>
            <p:cNvGrpSpPr/>
            <p:nvPr/>
          </p:nvGrpSpPr>
          <p:grpSpPr>
            <a:xfrm>
              <a:off x="1233020" y="2425627"/>
              <a:ext cx="537868" cy="2831338"/>
              <a:chOff x="8363166" y="2485050"/>
              <a:chExt cx="537868" cy="2317112"/>
            </a:xfrm>
          </p:grpSpPr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id="{76944F52-4866-E0F3-164C-B04D97F7C839}"/>
                  </a:ext>
                </a:extLst>
              </p:cNvPr>
              <p:cNvSpPr txBox="1"/>
              <p:nvPr/>
            </p:nvSpPr>
            <p:spPr>
              <a:xfrm>
                <a:off x="8363166" y="2485050"/>
                <a:ext cx="4988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10 kb</a:t>
                </a:r>
              </a:p>
            </p:txBody>
          </p:sp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4018EC51-C653-0797-8DBF-EAF0ADDF1B84}"/>
                  </a:ext>
                </a:extLst>
              </p:cNvPr>
              <p:cNvSpPr txBox="1"/>
              <p:nvPr/>
            </p:nvSpPr>
            <p:spPr>
              <a:xfrm>
                <a:off x="8388815" y="3099018"/>
                <a:ext cx="47320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1000</a:t>
                </a:r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9E2E65A9-5F24-8ECA-091F-32D6314CF7E7}"/>
                  </a:ext>
                </a:extLst>
              </p:cNvPr>
              <p:cNvSpPr txBox="1"/>
              <p:nvPr/>
            </p:nvSpPr>
            <p:spPr>
              <a:xfrm>
                <a:off x="8460949" y="4540552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200</a:t>
                </a:r>
              </a:p>
            </p:txBody>
          </p:sp>
          <p:sp>
            <p:nvSpPr>
              <p:cNvPr id="15" name="Cerrar corchete 14">
                <a:extLst>
                  <a:ext uri="{FF2B5EF4-FFF2-40B4-BE49-F238E27FC236}">
                    <a16:creationId xmlns:a16="http://schemas.microsoft.com/office/drawing/2014/main" id="{933DE4E1-2DDE-5671-BE93-9F5098C09591}"/>
                  </a:ext>
                </a:extLst>
              </p:cNvPr>
              <p:cNvSpPr/>
              <p:nvPr/>
            </p:nvSpPr>
            <p:spPr>
              <a:xfrm>
                <a:off x="8800163" y="3216817"/>
                <a:ext cx="100871" cy="1454540"/>
              </a:xfrm>
              <a:prstGeom prst="rightBracket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</p:grpSp>
        <p:grpSp>
          <p:nvGrpSpPr>
            <p:cNvPr id="16" name="Grupo 15">
              <a:extLst>
                <a:ext uri="{FF2B5EF4-FFF2-40B4-BE49-F238E27FC236}">
                  <a16:creationId xmlns:a16="http://schemas.microsoft.com/office/drawing/2014/main" id="{631C751A-756B-24EC-53E0-B74F8DFC754A}"/>
                </a:ext>
              </a:extLst>
            </p:cNvPr>
            <p:cNvGrpSpPr/>
            <p:nvPr/>
          </p:nvGrpSpPr>
          <p:grpSpPr>
            <a:xfrm>
              <a:off x="2382547" y="1038045"/>
              <a:ext cx="2949789" cy="472033"/>
              <a:chOff x="6174259" y="1135581"/>
              <a:chExt cx="2949789" cy="472033"/>
            </a:xfrm>
          </p:grpSpPr>
          <p:sp>
            <p:nvSpPr>
              <p:cNvPr id="17" name="Right Brace 5">
                <a:extLst>
                  <a:ext uri="{FF2B5EF4-FFF2-40B4-BE49-F238E27FC236}">
                    <a16:creationId xmlns:a16="http://schemas.microsoft.com/office/drawing/2014/main" id="{4CDB12DC-9028-613A-3160-A020EDACD2E5}"/>
                  </a:ext>
                </a:extLst>
              </p:cNvPr>
              <p:cNvSpPr/>
              <p:nvPr/>
            </p:nvSpPr>
            <p:spPr>
              <a:xfrm rot="16200000">
                <a:off x="6556245" y="1126444"/>
                <a:ext cx="97570" cy="861541"/>
              </a:xfrm>
              <a:prstGeom prst="rightBrac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MX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8" name="Right Brace 6">
                <a:extLst>
                  <a:ext uri="{FF2B5EF4-FFF2-40B4-BE49-F238E27FC236}">
                    <a16:creationId xmlns:a16="http://schemas.microsoft.com/office/drawing/2014/main" id="{C44C1EE7-9A3A-9EB4-01C1-F7A2B2636FD4}"/>
                  </a:ext>
                </a:extLst>
              </p:cNvPr>
              <p:cNvSpPr/>
              <p:nvPr/>
            </p:nvSpPr>
            <p:spPr>
              <a:xfrm rot="16200000">
                <a:off x="7598753" y="1126443"/>
                <a:ext cx="100800" cy="861542"/>
              </a:xfrm>
              <a:prstGeom prst="rightBrac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MX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9" name="TextBox 7">
                <a:extLst>
                  <a:ext uri="{FF2B5EF4-FFF2-40B4-BE49-F238E27FC236}">
                    <a16:creationId xmlns:a16="http://schemas.microsoft.com/office/drawing/2014/main" id="{67586A1C-B94D-6080-71C2-4D923BEB3A20}"/>
                  </a:ext>
                </a:extLst>
              </p:cNvPr>
              <p:cNvSpPr txBox="1"/>
              <p:nvPr/>
            </p:nvSpPr>
            <p:spPr>
              <a:xfrm>
                <a:off x="6248322" y="1135581"/>
                <a:ext cx="6703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MX" dirty="0"/>
                  <a:t>Col-0</a:t>
                </a:r>
              </a:p>
            </p:txBody>
          </p:sp>
          <p:sp>
            <p:nvSpPr>
              <p:cNvPr id="20" name="TextBox 8">
                <a:extLst>
                  <a:ext uri="{FF2B5EF4-FFF2-40B4-BE49-F238E27FC236}">
                    <a16:creationId xmlns:a16="http://schemas.microsoft.com/office/drawing/2014/main" id="{3604BBC9-F573-4E5B-354C-EE2FE91E3FF0}"/>
                  </a:ext>
                </a:extLst>
              </p:cNvPr>
              <p:cNvSpPr txBox="1"/>
              <p:nvPr/>
            </p:nvSpPr>
            <p:spPr>
              <a:xfrm>
                <a:off x="7295615" y="1135581"/>
                <a:ext cx="7494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MX" dirty="0"/>
                  <a:t>Cvi-0</a:t>
                </a:r>
              </a:p>
            </p:txBody>
          </p:sp>
          <p:sp>
            <p:nvSpPr>
              <p:cNvPr id="21" name="Right Brace 6">
                <a:extLst>
                  <a:ext uri="{FF2B5EF4-FFF2-40B4-BE49-F238E27FC236}">
                    <a16:creationId xmlns:a16="http://schemas.microsoft.com/office/drawing/2014/main" id="{80AAA6FA-6AB9-4F37-1867-92E70E9972FB}"/>
                  </a:ext>
                </a:extLst>
              </p:cNvPr>
              <p:cNvSpPr/>
              <p:nvPr/>
            </p:nvSpPr>
            <p:spPr>
              <a:xfrm rot="16200000">
                <a:off x="8642877" y="1126443"/>
                <a:ext cx="100800" cy="861542"/>
              </a:xfrm>
              <a:prstGeom prst="rightBrac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s-MX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2" name="TextBox 8">
                <a:extLst>
                  <a:ext uri="{FF2B5EF4-FFF2-40B4-BE49-F238E27FC236}">
                    <a16:creationId xmlns:a16="http://schemas.microsoft.com/office/drawing/2014/main" id="{A6968F7A-DC8B-2A2C-980C-EFC8E329F31A}"/>
                  </a:ext>
                </a:extLst>
              </p:cNvPr>
              <p:cNvSpPr txBox="1"/>
              <p:nvPr/>
            </p:nvSpPr>
            <p:spPr>
              <a:xfrm>
                <a:off x="8339739" y="1135581"/>
                <a:ext cx="7494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MX" dirty="0"/>
                  <a:t>Br</a:t>
                </a:r>
              </a:p>
            </p:txBody>
          </p:sp>
        </p:grp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5BE73979-A7C7-39AD-8F48-91432734FE14}"/>
              </a:ext>
            </a:extLst>
          </p:cNvPr>
          <p:cNvSpPr txBox="1"/>
          <p:nvPr/>
        </p:nvSpPr>
        <p:spPr>
          <a:xfrm>
            <a:off x="1200970" y="6726696"/>
            <a:ext cx="521995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 | Gel electrophoresis of sonicated self- and nonself-D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image shows a 2.2% agarose gel using ethidium bromide staining to verify the fragmentation obtained by sonication of self-DNA extracted from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-0, nonself-DNA from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halia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cotype Cap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rd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lands (Cvi-0) or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onself-DNA from broccoli (Br,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rassica olerace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each DNA source, the left line shows extracted DNA before sonication and the right lane shows the product after sonicating a solution of 500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ml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DNA in sterile distilled water for 3:30 min at 55% of amplitude and using pulse mode (1 s pulse ‘On’ and a 1 s pulse ‘Off’)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 a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505 ultrasonic processor (Col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me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Vernon Hills, IL, USA).</a:t>
            </a:r>
          </a:p>
        </p:txBody>
      </p:sp>
    </p:spTree>
    <p:extLst>
      <p:ext uri="{BB962C8B-B14F-4D97-AF65-F5344CB8AC3E}">
        <p14:creationId xmlns:p14="http://schemas.microsoft.com/office/powerpoint/2010/main" val="9655221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o 17">
            <a:extLst>
              <a:ext uri="{FF2B5EF4-FFF2-40B4-BE49-F238E27FC236}">
                <a16:creationId xmlns:a16="http://schemas.microsoft.com/office/drawing/2014/main" id="{61F5CC6D-9BB8-5995-D24A-F6E2CEE74A3E}"/>
              </a:ext>
            </a:extLst>
          </p:cNvPr>
          <p:cNvGrpSpPr/>
          <p:nvPr/>
        </p:nvGrpSpPr>
        <p:grpSpPr>
          <a:xfrm>
            <a:off x="622053" y="804607"/>
            <a:ext cx="5180456" cy="4148393"/>
            <a:chOff x="544069" y="1301169"/>
            <a:chExt cx="5180456" cy="4148393"/>
          </a:xfrm>
        </p:grpSpPr>
        <p:grpSp>
          <p:nvGrpSpPr>
            <p:cNvPr id="2" name="Group 25">
              <a:extLst>
                <a:ext uri="{FF2B5EF4-FFF2-40B4-BE49-F238E27FC236}">
                  <a16:creationId xmlns:a16="http://schemas.microsoft.com/office/drawing/2014/main" id="{D758F37A-B178-E00D-F943-E2CF20872BDA}"/>
                </a:ext>
              </a:extLst>
            </p:cNvPr>
            <p:cNvGrpSpPr/>
            <p:nvPr/>
          </p:nvGrpSpPr>
          <p:grpSpPr>
            <a:xfrm>
              <a:off x="1133475" y="1301169"/>
              <a:ext cx="4591050" cy="4148393"/>
              <a:chOff x="6375492" y="1442782"/>
              <a:chExt cx="4591050" cy="4148393"/>
            </a:xfrm>
          </p:grpSpPr>
          <p:grpSp>
            <p:nvGrpSpPr>
              <p:cNvPr id="3" name="Group 22">
                <a:extLst>
                  <a:ext uri="{FF2B5EF4-FFF2-40B4-BE49-F238E27FC236}">
                    <a16:creationId xmlns:a16="http://schemas.microsoft.com/office/drawing/2014/main" id="{66EBEB06-0D10-2DC7-A66A-00461B63DCB2}"/>
                  </a:ext>
                </a:extLst>
              </p:cNvPr>
              <p:cNvGrpSpPr/>
              <p:nvPr/>
            </p:nvGrpSpPr>
            <p:grpSpPr>
              <a:xfrm>
                <a:off x="6375492" y="1442782"/>
                <a:ext cx="4591050" cy="4148393"/>
                <a:chOff x="5495925" y="1442782"/>
                <a:chExt cx="4591050" cy="4148393"/>
              </a:xfrm>
            </p:grpSpPr>
            <p:pic>
              <p:nvPicPr>
                <p:cNvPr id="8" name="Picture 3">
                  <a:extLst>
                    <a:ext uri="{FF2B5EF4-FFF2-40B4-BE49-F238E27FC236}">
                      <a16:creationId xmlns:a16="http://schemas.microsoft.com/office/drawing/2014/main" id="{520BA01F-F71B-1E9A-85E2-5573BFCD6EA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495925" y="1952625"/>
                  <a:ext cx="4591050" cy="3638550"/>
                </a:xfrm>
                <a:prstGeom prst="rect">
                  <a:avLst/>
                </a:prstGeom>
              </p:spPr>
            </p:pic>
            <p:sp>
              <p:nvSpPr>
                <p:cNvPr id="9" name="Right Brace 5">
                  <a:extLst>
                    <a:ext uri="{FF2B5EF4-FFF2-40B4-BE49-F238E27FC236}">
                      <a16:creationId xmlns:a16="http://schemas.microsoft.com/office/drawing/2014/main" id="{CC1DC786-6885-322E-24EF-E4DC8903C54F}"/>
                    </a:ext>
                  </a:extLst>
                </p:cNvPr>
                <p:cNvSpPr/>
                <p:nvPr/>
              </p:nvSpPr>
              <p:spPr>
                <a:xfrm rot="16200000">
                  <a:off x="7046522" y="1218362"/>
                  <a:ext cx="97570" cy="1187504"/>
                </a:xfrm>
                <a:prstGeom prst="rightBrac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s-MX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0" name="Right Brace 6">
                  <a:extLst>
                    <a:ext uri="{FF2B5EF4-FFF2-40B4-BE49-F238E27FC236}">
                      <a16:creationId xmlns:a16="http://schemas.microsoft.com/office/drawing/2014/main" id="{A7E07C27-4918-E11E-0002-3AEB827DBAFA}"/>
                    </a:ext>
                  </a:extLst>
                </p:cNvPr>
                <p:cNvSpPr/>
                <p:nvPr/>
              </p:nvSpPr>
              <p:spPr>
                <a:xfrm rot="16200000">
                  <a:off x="8761022" y="1218362"/>
                  <a:ext cx="97570" cy="1187504"/>
                </a:xfrm>
                <a:prstGeom prst="rightBrac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s-MX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1" name="TextBox 7">
                  <a:extLst>
                    <a:ext uri="{FF2B5EF4-FFF2-40B4-BE49-F238E27FC236}">
                      <a16:creationId xmlns:a16="http://schemas.microsoft.com/office/drawing/2014/main" id="{7DC8FA6C-8250-552D-A41A-9716CBD740A4}"/>
                    </a:ext>
                  </a:extLst>
                </p:cNvPr>
                <p:cNvSpPr txBox="1"/>
                <p:nvPr/>
              </p:nvSpPr>
              <p:spPr>
                <a:xfrm>
                  <a:off x="6252608" y="1442782"/>
                  <a:ext cx="17005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MX" dirty="0"/>
                    <a:t>Non methylated</a:t>
                  </a:r>
                </a:p>
              </p:txBody>
            </p:sp>
            <p:sp>
              <p:nvSpPr>
                <p:cNvPr id="12" name="TextBox 8">
                  <a:extLst>
                    <a:ext uri="{FF2B5EF4-FFF2-40B4-BE49-F238E27FC236}">
                      <a16:creationId xmlns:a16="http://schemas.microsoft.com/office/drawing/2014/main" id="{71F8DD47-6835-9FD1-EC05-4495B0AC4FC3}"/>
                    </a:ext>
                  </a:extLst>
                </p:cNvPr>
                <p:cNvSpPr txBox="1"/>
                <p:nvPr/>
              </p:nvSpPr>
              <p:spPr>
                <a:xfrm>
                  <a:off x="8171367" y="1442782"/>
                  <a:ext cx="126778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MX" dirty="0"/>
                    <a:t>Methylated</a:t>
                  </a:r>
                </a:p>
              </p:txBody>
            </p:sp>
          </p:grpSp>
          <p:sp>
            <p:nvSpPr>
              <p:cNvPr id="4" name="TextBox 31">
                <a:extLst>
                  <a:ext uri="{FF2B5EF4-FFF2-40B4-BE49-F238E27FC236}">
                    <a16:creationId xmlns:a16="http://schemas.microsoft.com/office/drawing/2014/main" id="{F2C9735E-04F3-EAC3-7BD9-C0E9D4C2B2D3}"/>
                  </a:ext>
                </a:extLst>
              </p:cNvPr>
              <p:cNvSpPr txBox="1"/>
              <p:nvPr/>
            </p:nvSpPr>
            <p:spPr>
              <a:xfrm>
                <a:off x="7779874" y="1880054"/>
                <a:ext cx="52454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s-MX" sz="12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paII</a:t>
                </a:r>
                <a:endParaRPr lang="es-MX" sz="1200" dirty="0"/>
              </a:p>
            </p:txBody>
          </p:sp>
          <p:sp>
            <p:nvSpPr>
              <p:cNvPr id="5" name="TextBox 33">
                <a:extLst>
                  <a:ext uri="{FF2B5EF4-FFF2-40B4-BE49-F238E27FC236}">
                    <a16:creationId xmlns:a16="http://schemas.microsoft.com/office/drawing/2014/main" id="{073D91AE-AA9D-96FD-BA87-2E4AD7DE763A}"/>
                  </a:ext>
                </a:extLst>
              </p:cNvPr>
              <p:cNvSpPr txBox="1"/>
              <p:nvPr/>
            </p:nvSpPr>
            <p:spPr>
              <a:xfrm>
                <a:off x="9402112" y="1880054"/>
                <a:ext cx="52454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s-MX" sz="12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paII</a:t>
                </a:r>
                <a:endParaRPr lang="es-MX" sz="1200" dirty="0"/>
              </a:p>
            </p:txBody>
          </p:sp>
          <p:sp>
            <p:nvSpPr>
              <p:cNvPr id="6" name="TextBox 37">
                <a:extLst>
                  <a:ext uri="{FF2B5EF4-FFF2-40B4-BE49-F238E27FC236}">
                    <a16:creationId xmlns:a16="http://schemas.microsoft.com/office/drawing/2014/main" id="{849DF96D-BE5B-30B1-6A61-B29B9F79184D}"/>
                  </a:ext>
                </a:extLst>
              </p:cNvPr>
              <p:cNvSpPr txBox="1"/>
              <p:nvPr/>
            </p:nvSpPr>
            <p:spPr>
              <a:xfrm>
                <a:off x="8376082" y="1880054"/>
                <a:ext cx="52454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s-MX" sz="12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spI</a:t>
                </a:r>
                <a:endParaRPr lang="es-MX" sz="1200" dirty="0"/>
              </a:p>
            </p:txBody>
          </p:sp>
          <p:sp>
            <p:nvSpPr>
              <p:cNvPr id="7" name="TextBox 38">
                <a:extLst>
                  <a:ext uri="{FF2B5EF4-FFF2-40B4-BE49-F238E27FC236}">
                    <a16:creationId xmlns:a16="http://schemas.microsoft.com/office/drawing/2014/main" id="{DE7DEB4F-2B65-FAEB-D4A6-0D5CBB87F4CD}"/>
                  </a:ext>
                </a:extLst>
              </p:cNvPr>
              <p:cNvSpPr txBox="1"/>
              <p:nvPr/>
            </p:nvSpPr>
            <p:spPr>
              <a:xfrm>
                <a:off x="9888750" y="1880054"/>
                <a:ext cx="512075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s-MX" sz="12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spI</a:t>
                </a:r>
                <a:endParaRPr lang="es-MX" sz="1200" dirty="0"/>
              </a:p>
            </p:txBody>
          </p:sp>
        </p:grpSp>
        <p:grpSp>
          <p:nvGrpSpPr>
            <p:cNvPr id="13" name="Grupo 12">
              <a:extLst>
                <a:ext uri="{FF2B5EF4-FFF2-40B4-BE49-F238E27FC236}">
                  <a16:creationId xmlns:a16="http://schemas.microsoft.com/office/drawing/2014/main" id="{F2089DBE-0B37-9B11-D0D1-1F3F6A27A08C}"/>
                </a:ext>
              </a:extLst>
            </p:cNvPr>
            <p:cNvGrpSpPr/>
            <p:nvPr/>
          </p:nvGrpSpPr>
          <p:grpSpPr>
            <a:xfrm>
              <a:off x="544069" y="2412389"/>
              <a:ext cx="503402" cy="2560258"/>
              <a:chOff x="8424882" y="2853401"/>
              <a:chExt cx="503402" cy="2389031"/>
            </a:xfrm>
          </p:grpSpPr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F1B73D81-255A-D4D8-0B1E-60262BE5A992}"/>
                  </a:ext>
                </a:extLst>
              </p:cNvPr>
              <p:cNvSpPr txBox="1"/>
              <p:nvPr/>
            </p:nvSpPr>
            <p:spPr>
              <a:xfrm>
                <a:off x="8429429" y="2853401"/>
                <a:ext cx="498855" cy="2616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10 kb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E8B04240-F373-1205-4EB5-2385CC92E398}"/>
                  </a:ext>
                </a:extLst>
              </p:cNvPr>
              <p:cNvSpPr txBox="1"/>
              <p:nvPr/>
            </p:nvSpPr>
            <p:spPr>
              <a:xfrm>
                <a:off x="8424882" y="3490766"/>
                <a:ext cx="473206" cy="2616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1000</a:t>
                </a:r>
              </a:p>
            </p:txBody>
          </p:sp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70ED5D17-0602-E787-3E6E-F86B8C089F34}"/>
                  </a:ext>
                </a:extLst>
              </p:cNvPr>
              <p:cNvSpPr txBox="1"/>
              <p:nvPr/>
            </p:nvSpPr>
            <p:spPr>
              <a:xfrm>
                <a:off x="8460949" y="4980822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200</a:t>
                </a:r>
              </a:p>
            </p:txBody>
          </p:sp>
          <p:sp>
            <p:nvSpPr>
              <p:cNvPr id="17" name="Cerrar corchete 16">
                <a:extLst>
                  <a:ext uri="{FF2B5EF4-FFF2-40B4-BE49-F238E27FC236}">
                    <a16:creationId xmlns:a16="http://schemas.microsoft.com/office/drawing/2014/main" id="{5209CD81-8DC6-5298-5027-F8238069C54D}"/>
                  </a:ext>
                </a:extLst>
              </p:cNvPr>
              <p:cNvSpPr/>
              <p:nvPr/>
            </p:nvSpPr>
            <p:spPr>
              <a:xfrm>
                <a:off x="8800164" y="3647109"/>
                <a:ext cx="97924" cy="1464511"/>
              </a:xfrm>
              <a:prstGeom prst="rightBracket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</p:grpSp>
      </p:grpSp>
      <p:sp>
        <p:nvSpPr>
          <p:cNvPr id="25" name="CuadroTexto 24">
            <a:extLst>
              <a:ext uri="{FF2B5EF4-FFF2-40B4-BE49-F238E27FC236}">
                <a16:creationId xmlns:a16="http://schemas.microsoft.com/office/drawing/2014/main" id="{1A8AAACF-7307-D6A2-B49E-3F6CCDE58D2F}"/>
              </a:ext>
            </a:extLst>
          </p:cNvPr>
          <p:cNvSpPr txBox="1"/>
          <p:nvPr/>
        </p:nvSpPr>
        <p:spPr>
          <a:xfrm>
            <a:off x="284462" y="5082647"/>
            <a:ext cx="6056703" cy="40780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 | Confirmation for f</a:t>
            </a:r>
            <a:r>
              <a:rPr lang="en-GB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ll genomic methylation by M. </a:t>
            </a:r>
            <a:r>
              <a:rPr lang="en-GB" sz="11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ssI</a:t>
            </a:r>
            <a:r>
              <a:rPr lang="en-GB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confirm that treatment with the DNA methyltransferas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.Sss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1] allowed for a complete methylation of the cytosine residues in the 5’-CG-3’ motif,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.Sss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reated DNA was incubated with each of two restriction enzymes,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I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p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th restriction enzymes cleave unmethylated 5′-CCGG-3′ sequences between the two cytosines and none of them can cleave when the external cytosine residue is methylated, but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p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n cleave when the internal cytosine is methylated, whereas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aI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nnot [2;3;4]. We observed fragmentation after incubating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.Sss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reated DNA with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p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t not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aII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conclude that this observation indicates the full methylation of the CpG motifs.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[1] P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nbaum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rahamove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insod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G.G. Wilson, S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ttem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A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zin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loning, characterization, and expression in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scherichia col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the gene coding for the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pG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NA methylase from </a:t>
            </a:r>
            <a:r>
              <a:rPr lang="en-US" sz="10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iroplasma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. strain MW1 (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.Sss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leic Acids Res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8 (1990) 1145-1152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10.1093/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r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18.5.1145</a:t>
            </a:r>
            <a:endParaRPr lang="es-MX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[2] M. Labra, A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hian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tterio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gorbat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. Sala, C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nnin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. Ruffini-Castiglione, and M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cale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alysis of cytosine methylation pattern in response to water deficit in pea root tips.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nt Biol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4 (2002) 694-699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10.1055/s-2002-37398</a:t>
            </a:r>
            <a:endParaRPr lang="es-MX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[3] K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wialkowsk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U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rotko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sinsk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I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zarejko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M. Kwasniewski, Methylation sensitive amplification polymorphism sequencing (MSAP-Seq) - a method for high-throughput analysis of differentially methylated CCGG sites in plants with large genomes.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nt Plant Sc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8 (2017) art. 2056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10.3389/fpls.2017.02056</a:t>
            </a:r>
            <a:endParaRPr lang="es-MX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[4] Z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dov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rtosik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M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jt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gnetic bead-based electrochemical assay for determination of DNA methyltransferase activity. </a:t>
            </a:r>
            <a:r>
              <a:rPr lang="en-US" sz="10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ectrochim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ct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31 (2017) 575-581.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10.1016/j.electacta.2017.02.104</a:t>
            </a:r>
            <a:endParaRPr lang="es-MX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11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F1DD8F50-A176-ADCE-577C-E76F29325897}"/>
              </a:ext>
            </a:extLst>
          </p:cNvPr>
          <p:cNvSpPr txBox="1"/>
          <p:nvPr/>
        </p:nvSpPr>
        <p:spPr>
          <a:xfrm>
            <a:off x="3775316" y="1320280"/>
            <a:ext cx="2308243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 | </a:t>
            </a:r>
            <a:r>
              <a:rPr lang="en-GB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elf/nonself-specific time-curve induction of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JA</a:t>
            </a:r>
            <a:r>
              <a:rPr lang="en-GB" sz="1200" b="1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nd SA b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genous D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levels of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asmonic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cid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[in ng JA g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f fresh weight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 and salicylic acid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[in µg SA g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f fresh weight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 wer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 at different time points, 0, 15, 30, 45, and 60 min (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A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A), 0,, 12, 24 and 48 h (SA, panel B)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ter treating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thaliana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-0 plants with 5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µg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·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l</a:t>
            </a:r>
            <a:r>
              <a:rPr lang="en-GB" sz="1200" i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self-DNA (red symbols) or with nonself-DNA from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thalian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cotype Cap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rde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lands (Cvi-0, dark grey symbols)  or from broccoli (Br,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 olerace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ight grey symbols). Circles indicate individual data points, horizontal lines indicate means, and different letters indicat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ly significant differences among plants treated with DNA from different origins (p &lt; 0.05, post-hoc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ukey tests, 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e Supplementary datasheet for detailed results of statistical analyses).</a:t>
            </a:r>
          </a:p>
        </p:txBody>
      </p:sp>
      <p:pic>
        <p:nvPicPr>
          <p:cNvPr id="5" name="Imagen 4" descr="Gráfico&#10;&#10;Descripción generada automáticamente">
            <a:extLst>
              <a:ext uri="{FF2B5EF4-FFF2-40B4-BE49-F238E27FC236}">
                <a16:creationId xmlns:a16="http://schemas.microsoft.com/office/drawing/2014/main" id="{8B704418-3617-242D-9DBF-FDC2598733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590" y="1384075"/>
            <a:ext cx="3480385" cy="58353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30476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CuadroTexto 46">
            <a:extLst>
              <a:ext uri="{FF2B5EF4-FFF2-40B4-BE49-F238E27FC236}">
                <a16:creationId xmlns:a16="http://schemas.microsoft.com/office/drawing/2014/main" id="{CAD2BFCB-58F4-F5F5-1F4D-5025E0037DB3}"/>
              </a:ext>
            </a:extLst>
          </p:cNvPr>
          <p:cNvSpPr txBox="1"/>
          <p:nvPr/>
        </p:nvSpPr>
        <p:spPr>
          <a:xfrm>
            <a:off x="2029522" y="724829"/>
            <a:ext cx="37253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err="1"/>
              <a:t>Fragments</a:t>
            </a:r>
            <a:r>
              <a:rPr lang="es-ES_tradnl" dirty="0"/>
              <a:t> </a:t>
            </a:r>
            <a:r>
              <a:rPr lang="es-ES_tradnl" dirty="0" err="1"/>
              <a:t>percentage</a:t>
            </a:r>
            <a:r>
              <a:rPr lang="es-ES_tradnl" dirty="0"/>
              <a:t> </a:t>
            </a:r>
            <a:r>
              <a:rPr lang="es-ES_tradnl" dirty="0" err="1"/>
              <a:t>below</a:t>
            </a:r>
            <a:r>
              <a:rPr lang="es-ES_tradnl" dirty="0"/>
              <a:t> 1000 </a:t>
            </a:r>
            <a:r>
              <a:rPr lang="es-ES_tradnl" dirty="0" err="1"/>
              <a:t>bp</a:t>
            </a:r>
            <a:endParaRPr lang="es-ES_tradnl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E9E8D1F-00F5-EE1D-35E3-2ACEAB59E83D}"/>
              </a:ext>
            </a:extLst>
          </p:cNvPr>
          <p:cNvSpPr txBox="1"/>
          <p:nvPr/>
        </p:nvSpPr>
        <p:spPr>
          <a:xfrm>
            <a:off x="278840" y="5930610"/>
            <a:ext cx="619166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4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|  DNA fragments formed by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damag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hoto shows a 2.2% agarose gel stained with ethidium bromide (inset in Figure 3A). We used the Display Toolbox of Image Lab for conversion to a 3D image and  assessed intensity values in the size range 200 - 1000 bp to estimate 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ree of fragmentation. </a:t>
            </a:r>
            <a:r>
              <a:rPr lang="en-GB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g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–),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virulent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eudomonas </a:t>
            </a:r>
            <a:r>
              <a:rPr lang="en-GB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ringae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v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ycine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rrying vector pVSP61; </a:t>
            </a:r>
            <a:r>
              <a:rPr lang="en-GB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g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+), virulent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eudomonas </a:t>
            </a:r>
            <a:r>
              <a:rPr lang="en-GB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ringae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v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ycinea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rying vector pV288 with effector avrRpt2; </a:t>
            </a:r>
            <a:r>
              <a:rPr lang="en-GB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t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C3000,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eudomonas </a:t>
            </a:r>
            <a:r>
              <a:rPr lang="en-GB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ringae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v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omato DC3000; SA, salicylic acid; H</a:t>
            </a:r>
            <a:r>
              <a:rPr lang="en-GB" sz="1200" kern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kern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ydrogen peroxide; MSC, mechanical stress control</a:t>
            </a:r>
            <a:endParaRPr lang="es-ES_trad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upo 8">
            <a:extLst>
              <a:ext uri="{FF2B5EF4-FFF2-40B4-BE49-F238E27FC236}">
                <a16:creationId xmlns:a16="http://schemas.microsoft.com/office/drawing/2014/main" id="{04406274-2177-FBCB-F322-7C2853B61D76}"/>
              </a:ext>
            </a:extLst>
          </p:cNvPr>
          <p:cNvGrpSpPr/>
          <p:nvPr/>
        </p:nvGrpSpPr>
        <p:grpSpPr>
          <a:xfrm>
            <a:off x="771025" y="801868"/>
            <a:ext cx="5833517" cy="5330183"/>
            <a:chOff x="711323" y="1935593"/>
            <a:chExt cx="5833517" cy="5330183"/>
          </a:xfrm>
        </p:grpSpPr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BF20CE94-6655-635B-6BA1-59A244BCB1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388" t="20492" r="33874" b="13072"/>
            <a:stretch/>
          </p:blipFill>
          <p:spPr>
            <a:xfrm>
              <a:off x="760751" y="1935593"/>
              <a:ext cx="5211016" cy="4847456"/>
            </a:xfrm>
            <a:prstGeom prst="rect">
              <a:avLst/>
            </a:prstGeom>
          </p:spPr>
        </p:pic>
        <p:grpSp>
          <p:nvGrpSpPr>
            <p:cNvPr id="11" name="Grupo 10">
              <a:extLst>
                <a:ext uri="{FF2B5EF4-FFF2-40B4-BE49-F238E27FC236}">
                  <a16:creationId xmlns:a16="http://schemas.microsoft.com/office/drawing/2014/main" id="{325BDAD4-8B21-3E52-9378-13EA88E337B7}"/>
                </a:ext>
              </a:extLst>
            </p:cNvPr>
            <p:cNvGrpSpPr/>
            <p:nvPr/>
          </p:nvGrpSpPr>
          <p:grpSpPr>
            <a:xfrm>
              <a:off x="711323" y="5004490"/>
              <a:ext cx="2390222" cy="2261286"/>
              <a:chOff x="317796" y="6793001"/>
              <a:chExt cx="1804529" cy="1623612"/>
            </a:xfrm>
          </p:grpSpPr>
          <p:sp>
            <p:nvSpPr>
              <p:cNvPr id="34" name="Abrir corchete 33">
                <a:extLst>
                  <a:ext uri="{FF2B5EF4-FFF2-40B4-BE49-F238E27FC236}">
                    <a16:creationId xmlns:a16="http://schemas.microsoft.com/office/drawing/2014/main" id="{3A3E3C4E-FED1-22E6-63C3-E0A3513B8E13}"/>
                  </a:ext>
                </a:extLst>
              </p:cNvPr>
              <p:cNvSpPr/>
              <p:nvPr/>
            </p:nvSpPr>
            <p:spPr>
              <a:xfrm rot="17878278">
                <a:off x="1328953" y="6407678"/>
                <a:ext cx="187378" cy="1399367"/>
              </a:xfrm>
              <a:prstGeom prst="leftBracket">
                <a:avLst/>
              </a:prstGeom>
              <a:ln w="381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_tradnl" dirty="0"/>
              </a:p>
            </p:txBody>
          </p:sp>
          <p:sp>
            <p:nvSpPr>
              <p:cNvPr id="35" name="CuadroTexto 34">
                <a:extLst>
                  <a:ext uri="{FF2B5EF4-FFF2-40B4-BE49-F238E27FC236}">
                    <a16:creationId xmlns:a16="http://schemas.microsoft.com/office/drawing/2014/main" id="{CD514037-61D1-934D-0575-E93A816762FC}"/>
                  </a:ext>
                </a:extLst>
              </p:cNvPr>
              <p:cNvSpPr txBox="1"/>
              <p:nvPr/>
            </p:nvSpPr>
            <p:spPr>
              <a:xfrm rot="18028427">
                <a:off x="27812" y="7082985"/>
                <a:ext cx="94929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_tradnl" dirty="0"/>
                  <a:t>1000 pb</a:t>
                </a:r>
              </a:p>
            </p:txBody>
          </p: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FC42DA3F-1003-DD77-FA65-48D3F9AFE859}"/>
                  </a:ext>
                </a:extLst>
              </p:cNvPr>
              <p:cNvSpPr txBox="1"/>
              <p:nvPr/>
            </p:nvSpPr>
            <p:spPr>
              <a:xfrm rot="18028427">
                <a:off x="1178012" y="7759856"/>
                <a:ext cx="94418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s-ES_tradnl" dirty="0"/>
                  <a:t>200 pb</a:t>
                </a:r>
              </a:p>
            </p:txBody>
          </p:sp>
        </p:grpSp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12D6FDE5-9E4B-C0EF-D46A-A3BCCEF5B07E}"/>
                </a:ext>
              </a:extLst>
            </p:cNvPr>
            <p:cNvGrpSpPr/>
            <p:nvPr/>
          </p:nvGrpSpPr>
          <p:grpSpPr>
            <a:xfrm>
              <a:off x="3746335" y="3392124"/>
              <a:ext cx="2798505" cy="2887870"/>
              <a:chOff x="3746335" y="3392124"/>
              <a:chExt cx="2798505" cy="2887870"/>
            </a:xfrm>
          </p:grpSpPr>
          <p:grpSp>
            <p:nvGrpSpPr>
              <p:cNvPr id="13" name="Grupo 12">
                <a:extLst>
                  <a:ext uri="{FF2B5EF4-FFF2-40B4-BE49-F238E27FC236}">
                    <a16:creationId xmlns:a16="http://schemas.microsoft.com/office/drawing/2014/main" id="{C343FF41-EED5-3D9B-DBBF-251BB0AD16CD}"/>
                  </a:ext>
                </a:extLst>
              </p:cNvPr>
              <p:cNvGrpSpPr/>
              <p:nvPr/>
            </p:nvGrpSpPr>
            <p:grpSpPr>
              <a:xfrm>
                <a:off x="3746335" y="3513848"/>
                <a:ext cx="2348716" cy="2627647"/>
                <a:chOff x="3746335" y="3513848"/>
                <a:chExt cx="2348716" cy="2627647"/>
              </a:xfrm>
            </p:grpSpPr>
            <p:cxnSp>
              <p:nvCxnSpPr>
                <p:cNvPr id="24" name="Conector recto 23">
                  <a:extLst>
                    <a:ext uri="{FF2B5EF4-FFF2-40B4-BE49-F238E27FC236}">
                      <a16:creationId xmlns:a16="http://schemas.microsoft.com/office/drawing/2014/main" id="{52914CE2-28DC-2242-F6E9-EC46342D1392}"/>
                    </a:ext>
                  </a:extLst>
                </p:cNvPr>
                <p:cNvCxnSpPr/>
                <p:nvPr/>
              </p:nvCxnSpPr>
              <p:spPr>
                <a:xfrm>
                  <a:off x="4059678" y="5743906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Conector recto 24">
                  <a:extLst>
                    <a:ext uri="{FF2B5EF4-FFF2-40B4-BE49-F238E27FC236}">
                      <a16:creationId xmlns:a16="http://schemas.microsoft.com/office/drawing/2014/main" id="{3DD8CC70-6874-860D-5F39-63F7936FF53E}"/>
                    </a:ext>
                  </a:extLst>
                </p:cNvPr>
                <p:cNvCxnSpPr/>
                <p:nvPr/>
              </p:nvCxnSpPr>
              <p:spPr>
                <a:xfrm>
                  <a:off x="4330465" y="5331568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Conector recto 25">
                  <a:extLst>
                    <a:ext uri="{FF2B5EF4-FFF2-40B4-BE49-F238E27FC236}">
                      <a16:creationId xmlns:a16="http://schemas.microsoft.com/office/drawing/2014/main" id="{467959E7-32F0-58A6-3FA6-09D8E0D5887C}"/>
                    </a:ext>
                  </a:extLst>
                </p:cNvPr>
                <p:cNvCxnSpPr/>
                <p:nvPr/>
              </p:nvCxnSpPr>
              <p:spPr>
                <a:xfrm>
                  <a:off x="3746335" y="6141495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Conector recto 26">
                  <a:extLst>
                    <a:ext uri="{FF2B5EF4-FFF2-40B4-BE49-F238E27FC236}">
                      <a16:creationId xmlns:a16="http://schemas.microsoft.com/office/drawing/2014/main" id="{B4CF32CF-019E-4220-7005-F0D52D1B66F8}"/>
                    </a:ext>
                  </a:extLst>
                </p:cNvPr>
                <p:cNvCxnSpPr/>
                <p:nvPr/>
              </p:nvCxnSpPr>
              <p:spPr>
                <a:xfrm>
                  <a:off x="4619076" y="4957012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Conector recto 27">
                  <a:extLst>
                    <a:ext uri="{FF2B5EF4-FFF2-40B4-BE49-F238E27FC236}">
                      <a16:creationId xmlns:a16="http://schemas.microsoft.com/office/drawing/2014/main" id="{17181642-4426-52AA-42AA-468EE35D6EC8}"/>
                    </a:ext>
                  </a:extLst>
                </p:cNvPr>
                <p:cNvCxnSpPr/>
                <p:nvPr/>
              </p:nvCxnSpPr>
              <p:spPr>
                <a:xfrm>
                  <a:off x="4868576" y="4639629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Conector recto 28">
                  <a:extLst>
                    <a:ext uri="{FF2B5EF4-FFF2-40B4-BE49-F238E27FC236}">
                      <a16:creationId xmlns:a16="http://schemas.microsoft.com/office/drawing/2014/main" id="{F2DADE21-2787-E57F-6C47-E18B2CBF73B5}"/>
                    </a:ext>
                  </a:extLst>
                </p:cNvPr>
                <p:cNvCxnSpPr/>
                <p:nvPr/>
              </p:nvCxnSpPr>
              <p:spPr>
                <a:xfrm>
                  <a:off x="5067679" y="4360028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Conector recto 29">
                  <a:extLst>
                    <a:ext uri="{FF2B5EF4-FFF2-40B4-BE49-F238E27FC236}">
                      <a16:creationId xmlns:a16="http://schemas.microsoft.com/office/drawing/2014/main" id="{23DF3F11-3222-81D2-9516-77C1E16AA8E1}"/>
                    </a:ext>
                  </a:extLst>
                </p:cNvPr>
                <p:cNvCxnSpPr/>
                <p:nvPr/>
              </p:nvCxnSpPr>
              <p:spPr>
                <a:xfrm>
                  <a:off x="5237286" y="4095173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Conector recto 30">
                  <a:extLst>
                    <a:ext uri="{FF2B5EF4-FFF2-40B4-BE49-F238E27FC236}">
                      <a16:creationId xmlns:a16="http://schemas.microsoft.com/office/drawing/2014/main" id="{9D379B1C-1E52-810E-5784-3858A1D8B63E}"/>
                    </a:ext>
                  </a:extLst>
                </p:cNvPr>
                <p:cNvCxnSpPr/>
                <p:nvPr/>
              </p:nvCxnSpPr>
              <p:spPr>
                <a:xfrm>
                  <a:off x="5406893" y="3904062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Conector recto 31">
                  <a:extLst>
                    <a:ext uri="{FF2B5EF4-FFF2-40B4-BE49-F238E27FC236}">
                      <a16:creationId xmlns:a16="http://schemas.microsoft.com/office/drawing/2014/main" id="{4FCD0784-7B1B-4251-2870-1490082F0CE7}"/>
                    </a:ext>
                  </a:extLst>
                </p:cNvPr>
                <p:cNvCxnSpPr/>
                <p:nvPr/>
              </p:nvCxnSpPr>
              <p:spPr>
                <a:xfrm>
                  <a:off x="5682097" y="3513848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Conector recto 32">
                  <a:extLst>
                    <a:ext uri="{FF2B5EF4-FFF2-40B4-BE49-F238E27FC236}">
                      <a16:creationId xmlns:a16="http://schemas.microsoft.com/office/drawing/2014/main" id="{08B71B9F-E647-548F-374F-DF6F59160144}"/>
                    </a:ext>
                  </a:extLst>
                </p:cNvPr>
                <p:cNvCxnSpPr/>
                <p:nvPr/>
              </p:nvCxnSpPr>
              <p:spPr>
                <a:xfrm>
                  <a:off x="5541987" y="3703119"/>
                  <a:ext cx="41295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F6E67DAB-77C1-8BD3-90B6-0E0EC8CC00D9}"/>
                  </a:ext>
                </a:extLst>
              </p:cNvPr>
              <p:cNvSpPr txBox="1"/>
              <p:nvPr/>
            </p:nvSpPr>
            <p:spPr>
              <a:xfrm>
                <a:off x="4159289" y="6002995"/>
                <a:ext cx="9028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200" dirty="0"/>
                  <a:t>DNA </a:t>
                </a:r>
                <a:r>
                  <a:rPr lang="es-ES_tradnl" sz="1200" dirty="0" err="1"/>
                  <a:t>ladder</a:t>
                </a:r>
                <a:endParaRPr lang="es-ES_tradnl" sz="1200" dirty="0"/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78A384A1-AEE3-C686-2942-8E287083A4D6}"/>
                  </a:ext>
                </a:extLst>
              </p:cNvPr>
              <p:cNvSpPr txBox="1"/>
              <p:nvPr/>
            </p:nvSpPr>
            <p:spPr>
              <a:xfrm>
                <a:off x="4472632" y="5618206"/>
                <a:ext cx="7457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200" dirty="0" err="1"/>
                  <a:t>Genomic</a:t>
                </a:r>
                <a:endParaRPr lang="es-ES_tradnl" sz="1200" dirty="0"/>
              </a:p>
            </p:txBody>
          </p:sp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93A802EE-4DA9-5F17-10F9-ED707DD18665}"/>
                  </a:ext>
                </a:extLst>
              </p:cNvPr>
              <p:cNvSpPr txBox="1"/>
              <p:nvPr/>
            </p:nvSpPr>
            <p:spPr>
              <a:xfrm>
                <a:off x="4741798" y="5203077"/>
                <a:ext cx="7958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200" dirty="0" err="1"/>
                  <a:t>Sonicated</a:t>
                </a:r>
                <a:endParaRPr lang="es-ES_tradnl" sz="1200" dirty="0"/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C256F77A-9A26-7F7C-8F3C-3B82F7F897EC}"/>
                  </a:ext>
                </a:extLst>
              </p:cNvPr>
              <p:cNvSpPr txBox="1"/>
              <p:nvPr/>
            </p:nvSpPr>
            <p:spPr>
              <a:xfrm>
                <a:off x="5035968" y="4814500"/>
                <a:ext cx="5774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200" i="1" dirty="0" err="1"/>
                  <a:t>Psg</a:t>
                </a:r>
                <a:r>
                  <a:rPr lang="es-ES_tradnl" sz="1200" dirty="0"/>
                  <a:t> (-)</a:t>
                </a:r>
              </a:p>
            </p:txBody>
          </p:sp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id="{BF456860-62B9-2238-6751-7A2C9BF63D08}"/>
                  </a:ext>
                </a:extLst>
              </p:cNvPr>
              <p:cNvSpPr txBox="1"/>
              <p:nvPr/>
            </p:nvSpPr>
            <p:spPr>
              <a:xfrm>
                <a:off x="5297887" y="4501129"/>
                <a:ext cx="6078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200" i="1" dirty="0" err="1"/>
                  <a:t>Psg</a:t>
                </a:r>
                <a:r>
                  <a:rPr lang="es-ES_tradnl" sz="1200" dirty="0"/>
                  <a:t> (+)</a:t>
                </a:r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CE3C8127-2F81-89A8-582B-EA83F46E7D4B}"/>
                  </a:ext>
                </a:extLst>
              </p:cNvPr>
              <p:cNvSpPr txBox="1"/>
              <p:nvPr/>
            </p:nvSpPr>
            <p:spPr>
              <a:xfrm>
                <a:off x="5503665" y="4214649"/>
                <a:ext cx="3736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200" i="1" dirty="0" err="1"/>
                  <a:t>Pst</a:t>
                </a:r>
                <a:endParaRPr lang="es-ES_tradnl" sz="1200" dirty="0"/>
              </a:p>
            </p:txBody>
          </p:sp>
          <p:sp>
            <p:nvSpPr>
              <p:cNvPr id="20" name="CuadroTexto 19">
                <a:extLst>
                  <a:ext uri="{FF2B5EF4-FFF2-40B4-BE49-F238E27FC236}">
                    <a16:creationId xmlns:a16="http://schemas.microsoft.com/office/drawing/2014/main" id="{C28EDE65-45FA-FC40-5D7B-4FC32D1C0535}"/>
                  </a:ext>
                </a:extLst>
              </p:cNvPr>
              <p:cNvSpPr txBox="1"/>
              <p:nvPr/>
            </p:nvSpPr>
            <p:spPr>
              <a:xfrm>
                <a:off x="5682097" y="3956673"/>
                <a:ext cx="77938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 err="1"/>
                  <a:t>Bleomycin</a:t>
                </a:r>
                <a:endParaRPr lang="es-ES_tradnl" sz="1100" dirty="0"/>
              </a:p>
            </p:txBody>
          </p:sp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76842560-4A25-E517-F46E-B2234392123D}"/>
                  </a:ext>
                </a:extLst>
              </p:cNvPr>
              <p:cNvSpPr txBox="1"/>
              <p:nvPr/>
            </p:nvSpPr>
            <p:spPr>
              <a:xfrm>
                <a:off x="5819847" y="3769578"/>
                <a:ext cx="33054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SA</a:t>
                </a:r>
              </a:p>
            </p:txBody>
          </p:sp>
          <p:sp>
            <p:nvSpPr>
              <p:cNvPr id="22" name="CuadroTexto 21">
                <a:extLst>
                  <a:ext uri="{FF2B5EF4-FFF2-40B4-BE49-F238E27FC236}">
                    <a16:creationId xmlns:a16="http://schemas.microsoft.com/office/drawing/2014/main" id="{58685E75-755B-2064-E23C-6C7FF03EB73D}"/>
                  </a:ext>
                </a:extLst>
              </p:cNvPr>
              <p:cNvSpPr txBox="1"/>
              <p:nvPr/>
            </p:nvSpPr>
            <p:spPr>
              <a:xfrm>
                <a:off x="5975393" y="3580307"/>
                <a:ext cx="46198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H</a:t>
                </a:r>
                <a:r>
                  <a:rPr lang="es-ES_tradnl" sz="1100" baseline="-25000" dirty="0"/>
                  <a:t>2</a:t>
                </a:r>
                <a:r>
                  <a:rPr lang="es-ES_tradnl" sz="1100" dirty="0"/>
                  <a:t>O</a:t>
                </a:r>
                <a:r>
                  <a:rPr lang="es-ES_tradnl" sz="1100" baseline="-25000" dirty="0"/>
                  <a:t>2</a:t>
                </a:r>
              </a:p>
            </p:txBody>
          </p:sp>
          <p:sp>
            <p:nvSpPr>
              <p:cNvPr id="23" name="CuadroTexto 22">
                <a:extLst>
                  <a:ext uri="{FF2B5EF4-FFF2-40B4-BE49-F238E27FC236}">
                    <a16:creationId xmlns:a16="http://schemas.microsoft.com/office/drawing/2014/main" id="{EF4BE076-C60E-15F2-7F13-89BBBA8D629E}"/>
                  </a:ext>
                </a:extLst>
              </p:cNvPr>
              <p:cNvSpPr txBox="1"/>
              <p:nvPr/>
            </p:nvSpPr>
            <p:spPr>
              <a:xfrm>
                <a:off x="6100488" y="3392124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MSC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241419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upo 27">
            <a:extLst>
              <a:ext uri="{FF2B5EF4-FFF2-40B4-BE49-F238E27FC236}">
                <a16:creationId xmlns:a16="http://schemas.microsoft.com/office/drawing/2014/main" id="{E0E5A7DA-ED90-B7DF-8830-9969CE4F9DBB}"/>
              </a:ext>
            </a:extLst>
          </p:cNvPr>
          <p:cNvGrpSpPr/>
          <p:nvPr/>
        </p:nvGrpSpPr>
        <p:grpSpPr>
          <a:xfrm>
            <a:off x="1465040" y="546235"/>
            <a:ext cx="3927921" cy="4149341"/>
            <a:chOff x="1733068" y="1097216"/>
            <a:chExt cx="3927921" cy="4149341"/>
          </a:xfrm>
        </p:grpSpPr>
        <p:pic>
          <p:nvPicPr>
            <p:cNvPr id="22" name="Imagen 21">
              <a:extLst>
                <a:ext uri="{FF2B5EF4-FFF2-40B4-BE49-F238E27FC236}">
                  <a16:creationId xmlns:a16="http://schemas.microsoft.com/office/drawing/2014/main" id="{A593723E-55CF-2A6D-2662-B353D3EB63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73265" y="2294995"/>
              <a:ext cx="3287724" cy="2951562"/>
            </a:xfrm>
            <a:prstGeom prst="rect">
              <a:avLst/>
            </a:prstGeom>
          </p:spPr>
        </p:pic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0E0BAC8D-A51C-F2C6-CA46-A0A5190E07E3}"/>
                </a:ext>
              </a:extLst>
            </p:cNvPr>
            <p:cNvGrpSpPr/>
            <p:nvPr/>
          </p:nvGrpSpPr>
          <p:grpSpPr>
            <a:xfrm>
              <a:off x="1733068" y="3507717"/>
              <a:ext cx="826464" cy="1680555"/>
              <a:chOff x="7022135" y="2695019"/>
              <a:chExt cx="826464" cy="1680555"/>
            </a:xfrm>
          </p:grpSpPr>
          <p:sp>
            <p:nvSpPr>
              <p:cNvPr id="5" name="CuadroTexto 4">
                <a:extLst>
                  <a:ext uri="{FF2B5EF4-FFF2-40B4-BE49-F238E27FC236}">
                    <a16:creationId xmlns:a16="http://schemas.microsoft.com/office/drawing/2014/main" id="{166531A8-9F01-3194-DF9A-0268F30448EF}"/>
                  </a:ext>
                </a:extLst>
              </p:cNvPr>
              <p:cNvSpPr txBox="1"/>
              <p:nvPr/>
            </p:nvSpPr>
            <p:spPr>
              <a:xfrm>
                <a:off x="7022135" y="2695019"/>
                <a:ext cx="47320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1500</a:t>
                </a:r>
              </a:p>
            </p:txBody>
          </p:sp>
          <p:sp>
            <p:nvSpPr>
              <p:cNvPr id="6" name="CuadroTexto 5">
                <a:extLst>
                  <a:ext uri="{FF2B5EF4-FFF2-40B4-BE49-F238E27FC236}">
                    <a16:creationId xmlns:a16="http://schemas.microsoft.com/office/drawing/2014/main" id="{D24D7896-140F-CD97-3C02-42B92E859B88}"/>
                  </a:ext>
                </a:extLst>
              </p:cNvPr>
              <p:cNvSpPr txBox="1"/>
              <p:nvPr/>
            </p:nvSpPr>
            <p:spPr>
              <a:xfrm>
                <a:off x="7047784" y="3025011"/>
                <a:ext cx="473206" cy="2437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1000</a:t>
                </a:r>
              </a:p>
            </p:txBody>
          </p:sp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66800969-1F4C-E35B-DE5C-B508EA95B04B}"/>
                  </a:ext>
                </a:extLst>
              </p:cNvPr>
              <p:cNvSpPr txBox="1"/>
              <p:nvPr/>
            </p:nvSpPr>
            <p:spPr>
              <a:xfrm>
                <a:off x="7119918" y="4113964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200</a:t>
                </a:r>
              </a:p>
            </p:txBody>
          </p:sp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3C1692BF-E9B1-1614-058B-0247CB660826}"/>
                  </a:ext>
                </a:extLst>
              </p:cNvPr>
              <p:cNvSpPr txBox="1"/>
              <p:nvPr/>
            </p:nvSpPr>
            <p:spPr>
              <a:xfrm>
                <a:off x="7119918" y="3336092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700</a:t>
                </a:r>
              </a:p>
            </p:txBody>
          </p:sp>
          <p:sp>
            <p:nvSpPr>
              <p:cNvPr id="9" name="CuadroTexto 8">
                <a:extLst>
                  <a:ext uri="{FF2B5EF4-FFF2-40B4-BE49-F238E27FC236}">
                    <a16:creationId xmlns:a16="http://schemas.microsoft.com/office/drawing/2014/main" id="{E0E63379-EB40-9CC2-2164-EEBB45BD6E4F}"/>
                  </a:ext>
                </a:extLst>
              </p:cNvPr>
              <p:cNvSpPr txBox="1"/>
              <p:nvPr/>
            </p:nvSpPr>
            <p:spPr>
              <a:xfrm>
                <a:off x="7119918" y="3630818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100" dirty="0"/>
                  <a:t>500</a:t>
                </a:r>
              </a:p>
            </p:txBody>
          </p:sp>
          <p:cxnSp>
            <p:nvCxnSpPr>
              <p:cNvPr id="10" name="Conector recto 9">
                <a:extLst>
                  <a:ext uri="{FF2B5EF4-FFF2-40B4-BE49-F238E27FC236}">
                    <a16:creationId xmlns:a16="http://schemas.microsoft.com/office/drawing/2014/main" id="{6A444870-CCD5-AF4E-99DF-7EB8B0FBCB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76066" y="2816884"/>
                <a:ext cx="37253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Conector recto 10">
                <a:extLst>
                  <a:ext uri="{FF2B5EF4-FFF2-40B4-BE49-F238E27FC236}">
                    <a16:creationId xmlns:a16="http://schemas.microsoft.com/office/drawing/2014/main" id="{CAE6A5B4-2AC0-E293-42FF-11837264D9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76066" y="3146876"/>
                <a:ext cx="37253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Conector recto 11">
                <a:extLst>
                  <a:ext uri="{FF2B5EF4-FFF2-40B4-BE49-F238E27FC236}">
                    <a16:creationId xmlns:a16="http://schemas.microsoft.com/office/drawing/2014/main" id="{EE00C3DC-FFB7-79A0-3D26-A0F467C1AF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76066" y="3466897"/>
                <a:ext cx="37253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Conector recto 12">
                <a:extLst>
                  <a:ext uri="{FF2B5EF4-FFF2-40B4-BE49-F238E27FC236}">
                    <a16:creationId xmlns:a16="http://schemas.microsoft.com/office/drawing/2014/main" id="{C93C4288-9DBA-4BBC-A20B-1CD6E5E231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76066" y="3761623"/>
                <a:ext cx="37253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Conector recto 13">
                <a:extLst>
                  <a:ext uri="{FF2B5EF4-FFF2-40B4-BE49-F238E27FC236}">
                    <a16:creationId xmlns:a16="http://schemas.microsoft.com/office/drawing/2014/main" id="{A8C070F9-A59E-CAC4-ADB7-14E12DA66B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76066" y="4248229"/>
                <a:ext cx="37253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upo 26">
              <a:extLst>
                <a:ext uri="{FF2B5EF4-FFF2-40B4-BE49-F238E27FC236}">
                  <a16:creationId xmlns:a16="http://schemas.microsoft.com/office/drawing/2014/main" id="{CE61C2B7-25F0-27E6-43AB-27B51D3EA76D}"/>
                </a:ext>
              </a:extLst>
            </p:cNvPr>
            <p:cNvGrpSpPr/>
            <p:nvPr/>
          </p:nvGrpSpPr>
          <p:grpSpPr>
            <a:xfrm>
              <a:off x="2559532" y="1097216"/>
              <a:ext cx="2523314" cy="1265090"/>
              <a:chOff x="2559532" y="1097216"/>
              <a:chExt cx="2523314" cy="1265090"/>
            </a:xfrm>
          </p:grpSpPr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CFA201AB-7056-C6D8-5CCF-D22858B3A97D}"/>
                  </a:ext>
                </a:extLst>
              </p:cNvPr>
              <p:cNvSpPr txBox="1"/>
              <p:nvPr/>
            </p:nvSpPr>
            <p:spPr>
              <a:xfrm rot="16200000">
                <a:off x="2111653" y="1545095"/>
                <a:ext cx="126509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DNA </a:t>
                </a:r>
                <a:r>
                  <a:rPr lang="es-ES_tradnl" dirty="0" err="1"/>
                  <a:t>ladder</a:t>
                </a:r>
                <a:endParaRPr lang="es-ES_tradnl" dirty="0"/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2303D9A7-615D-5A91-8818-830F5DCAB7C9}"/>
                  </a:ext>
                </a:extLst>
              </p:cNvPr>
              <p:cNvSpPr txBox="1"/>
              <p:nvPr/>
            </p:nvSpPr>
            <p:spPr>
              <a:xfrm rot="16200000">
                <a:off x="2805267" y="1715462"/>
                <a:ext cx="9243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WT-atm</a:t>
                </a:r>
              </a:p>
            </p:txBody>
          </p:sp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id="{461557D5-3105-8724-5BDF-396AC76823C2}"/>
                  </a:ext>
                </a:extLst>
              </p:cNvPr>
              <p:cNvSpPr txBox="1"/>
              <p:nvPr/>
            </p:nvSpPr>
            <p:spPr>
              <a:xfrm rot="16200000">
                <a:off x="3375161" y="1737519"/>
                <a:ext cx="8802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HZ-</a:t>
                </a:r>
                <a:r>
                  <a:rPr lang="es-ES_tradnl" i="1" dirty="0"/>
                  <a:t>atm</a:t>
                </a:r>
              </a:p>
            </p:txBody>
          </p:sp>
          <p:sp>
            <p:nvSpPr>
              <p:cNvPr id="23" name="CuadroTexto 22">
                <a:extLst>
                  <a:ext uri="{FF2B5EF4-FFF2-40B4-BE49-F238E27FC236}">
                    <a16:creationId xmlns:a16="http://schemas.microsoft.com/office/drawing/2014/main" id="{AFA76BE8-1D15-FA02-5ADD-73E06BA5C2CF}"/>
                  </a:ext>
                </a:extLst>
              </p:cNvPr>
              <p:cNvSpPr txBox="1"/>
              <p:nvPr/>
            </p:nvSpPr>
            <p:spPr>
              <a:xfrm rot="16200000">
                <a:off x="3955253" y="1767559"/>
                <a:ext cx="8201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WT-</a:t>
                </a:r>
                <a:r>
                  <a:rPr lang="es-ES_tradnl" dirty="0" err="1"/>
                  <a:t>atr</a:t>
                </a:r>
                <a:endParaRPr lang="es-ES_tradnl" dirty="0"/>
              </a:p>
            </p:txBody>
          </p:sp>
          <p:sp>
            <p:nvSpPr>
              <p:cNvPr id="24" name="CuadroTexto 23">
                <a:extLst>
                  <a:ext uri="{FF2B5EF4-FFF2-40B4-BE49-F238E27FC236}">
                    <a16:creationId xmlns:a16="http://schemas.microsoft.com/office/drawing/2014/main" id="{133C3A6A-1CB2-07C1-8FA6-757695645780}"/>
                  </a:ext>
                </a:extLst>
              </p:cNvPr>
              <p:cNvSpPr txBox="1"/>
              <p:nvPr/>
            </p:nvSpPr>
            <p:spPr>
              <a:xfrm rot="16200000">
                <a:off x="4510157" y="1789617"/>
                <a:ext cx="77604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HZ-</a:t>
                </a:r>
                <a:r>
                  <a:rPr lang="es-ES_tradnl" i="1" dirty="0" err="1"/>
                  <a:t>atr</a:t>
                </a:r>
                <a:endParaRPr lang="es-ES_tradnl" i="1" dirty="0"/>
              </a:p>
            </p:txBody>
          </p:sp>
        </p:grpSp>
      </p:grpSp>
      <p:graphicFrame>
        <p:nvGraphicFramePr>
          <p:cNvPr id="29" name="Tabla 29">
            <a:extLst>
              <a:ext uri="{FF2B5EF4-FFF2-40B4-BE49-F238E27FC236}">
                <a16:creationId xmlns:a16="http://schemas.microsoft.com/office/drawing/2014/main" id="{6DD953EF-2076-8FB1-F2E6-920017EB8D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8376414"/>
              </p:ext>
            </p:extLst>
          </p:nvPr>
        </p:nvGraphicFramePr>
        <p:xfrm>
          <a:off x="1479313" y="5034342"/>
          <a:ext cx="3899375" cy="111252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594043">
                  <a:extLst>
                    <a:ext uri="{9D8B030D-6E8A-4147-A177-3AD203B41FA5}">
                      <a16:colId xmlns:a16="http://schemas.microsoft.com/office/drawing/2014/main" val="379926739"/>
                    </a:ext>
                  </a:extLst>
                </a:gridCol>
                <a:gridCol w="1652666">
                  <a:extLst>
                    <a:ext uri="{9D8B030D-6E8A-4147-A177-3AD203B41FA5}">
                      <a16:colId xmlns:a16="http://schemas.microsoft.com/office/drawing/2014/main" val="3966922464"/>
                    </a:ext>
                  </a:extLst>
                </a:gridCol>
                <a:gridCol w="1652666">
                  <a:extLst>
                    <a:ext uri="{9D8B030D-6E8A-4147-A177-3AD203B41FA5}">
                      <a16:colId xmlns:a16="http://schemas.microsoft.com/office/drawing/2014/main" val="3509070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s-ES_tradnl" dirty="0"/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dirty="0"/>
                        <a:t>WT </a:t>
                      </a:r>
                      <a:r>
                        <a:rPr lang="es-ES_tradnl" dirty="0" err="1"/>
                        <a:t>product</a:t>
                      </a:r>
                      <a:r>
                        <a:rPr lang="es-ES_tradnl" dirty="0"/>
                        <a:t> </a:t>
                      </a:r>
                      <a:r>
                        <a:rPr lang="es-ES_tradnl" dirty="0" err="1"/>
                        <a:t>size</a:t>
                      </a:r>
                      <a:endParaRPr lang="es-ES_trad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dirty="0" err="1"/>
                        <a:t>Mutant</a:t>
                      </a:r>
                      <a:r>
                        <a:rPr lang="es-ES_tradnl" dirty="0"/>
                        <a:t> </a:t>
                      </a:r>
                      <a:r>
                        <a:rPr lang="es-ES_tradnl" dirty="0" err="1"/>
                        <a:t>product</a:t>
                      </a:r>
                      <a:r>
                        <a:rPr lang="es-ES_tradnl" dirty="0"/>
                        <a:t> </a:t>
                      </a:r>
                      <a:r>
                        <a:rPr lang="es-ES_tradnl" dirty="0" err="1"/>
                        <a:t>size</a:t>
                      </a:r>
                      <a:endParaRPr lang="es-ES_tradnl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9292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s-ES_tradnl" dirty="0"/>
                        <a:t>at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dirty="0"/>
                        <a:t>11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dirty="0"/>
                        <a:t>512-8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36324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s-ES_tradnl" dirty="0" err="1"/>
                        <a:t>atr</a:t>
                      </a:r>
                      <a:endParaRPr lang="es-ES_tradnl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dirty="0"/>
                        <a:t>10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_tradnl" dirty="0"/>
                        <a:t>468-76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2232636"/>
                  </a:ext>
                </a:extLst>
              </a:tr>
            </a:tbl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0412E660-8966-4261-6869-AD70AF19A290}"/>
              </a:ext>
            </a:extLst>
          </p:cNvPr>
          <p:cNvSpPr txBox="1"/>
          <p:nvPr/>
        </p:nvSpPr>
        <p:spPr>
          <a:xfrm>
            <a:off x="1205301" y="8162454"/>
            <a:ext cx="52199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 | Arabidopsis T-DNA mutants genotyping</a:t>
            </a:r>
            <a:endParaRPr lang="en-GB" sz="12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s-MX" sz="1200" dirty="0"/>
              <a:t>T-DNA </a:t>
            </a:r>
            <a:r>
              <a:rPr lang="es-MX" sz="1200" dirty="0" err="1"/>
              <a:t>insertion</a:t>
            </a:r>
            <a:r>
              <a:rPr lang="es-MX" sz="1200" dirty="0"/>
              <a:t> </a:t>
            </a:r>
            <a:r>
              <a:rPr lang="es-MX" sz="1200" dirty="0" err="1"/>
              <a:t>mutants</a:t>
            </a:r>
            <a:r>
              <a:rPr lang="es-MX" sz="1200" dirty="0"/>
              <a:t> </a:t>
            </a:r>
            <a:r>
              <a:rPr lang="es-MX" sz="1200" dirty="0" err="1"/>
              <a:t>for</a:t>
            </a:r>
            <a:r>
              <a:rPr lang="es-MX" sz="1200" dirty="0"/>
              <a:t> </a:t>
            </a:r>
            <a:r>
              <a:rPr lang="es-MX" sz="1200" dirty="0" err="1"/>
              <a:t>the</a:t>
            </a:r>
            <a:r>
              <a:rPr lang="es-MX" sz="1200" dirty="0"/>
              <a:t> atm and atr gene in Arabidopsis thaliana and its expression pattern as analyzed </a:t>
            </a:r>
            <a:r>
              <a:rPr lang="es-MX" sz="1200" dirty="0" err="1"/>
              <a:t>by</a:t>
            </a:r>
            <a:r>
              <a:rPr lang="es-MX" sz="1200" dirty="0"/>
              <a:t> </a:t>
            </a:r>
            <a:r>
              <a:rPr lang="es-MX" sz="1200" dirty="0" err="1"/>
              <a:t>genotyping</a:t>
            </a:r>
            <a:r>
              <a:rPr lang="es-MX" sz="1200" dirty="0"/>
              <a:t>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Tabla 14">
            <a:extLst>
              <a:ext uri="{FF2B5EF4-FFF2-40B4-BE49-F238E27FC236}">
                <a16:creationId xmlns:a16="http://schemas.microsoft.com/office/drawing/2014/main" id="{AFC17D19-9A3F-8895-FE43-6C26144678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5091041"/>
              </p:ext>
            </p:extLst>
          </p:nvPr>
        </p:nvGraphicFramePr>
        <p:xfrm>
          <a:off x="626110" y="6410473"/>
          <a:ext cx="5605780" cy="1475994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2802890">
                  <a:extLst>
                    <a:ext uri="{9D8B030D-6E8A-4147-A177-3AD203B41FA5}">
                      <a16:colId xmlns:a16="http://schemas.microsoft.com/office/drawing/2014/main" val="1249350030"/>
                    </a:ext>
                  </a:extLst>
                </a:gridCol>
                <a:gridCol w="2802890">
                  <a:extLst>
                    <a:ext uri="{9D8B030D-6E8A-4147-A177-3AD203B41FA5}">
                      <a16:colId xmlns:a16="http://schemas.microsoft.com/office/drawing/2014/main" val="409094096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Genotyping primers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5’ – 3’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265699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LBb1.3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s-MX" sz="1000">
                          <a:effectLst/>
                        </a:rPr>
                        <a:t>ATTTTGCCGATTTCGGAAC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244692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atm_lp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TCTCCGAGGAATCATCTGTTG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976360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 err="1">
                          <a:effectLst/>
                        </a:rPr>
                        <a:t>atm_rp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TTAGAAAACTGACCCGAAGGG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580348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atr_lp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GCAGCAAAAATTTCTTGGTTG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343614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atr_rp</a:t>
                      </a:r>
                      <a:endParaRPr lang="es-MX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ACTTCAAGGGTTCCGATGTTC</a:t>
                      </a:r>
                      <a:endParaRPr lang="es-MX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698934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30973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84</TotalTime>
  <Words>1002</Words>
  <Application>Microsoft Macintosh PowerPoint</Application>
  <PresentationFormat>A4 (210 x 297 mm)</PresentationFormat>
  <Paragraphs>77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tin Heil</dc:creator>
  <cp:lastModifiedBy>Isaac Vega Munoz</cp:lastModifiedBy>
  <cp:revision>40</cp:revision>
  <cp:lastPrinted>2023-02-22T00:10:42Z</cp:lastPrinted>
  <dcterms:created xsi:type="dcterms:W3CDTF">2022-11-23T21:51:21Z</dcterms:created>
  <dcterms:modified xsi:type="dcterms:W3CDTF">2023-05-04T16:44:14Z</dcterms:modified>
</cp:coreProperties>
</file>